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84201"/>
  </p:normalViewPr>
  <p:slideViewPr>
    <p:cSldViewPr snapToGrid="0" snapToObjects="1">
      <p:cViewPr varScale="1">
        <p:scale>
          <a:sx n="101" d="100"/>
          <a:sy n="101" d="100"/>
        </p:scale>
        <p:origin x="232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B69E37-C59B-B348-B051-EE389495585E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D6D64-4201-BD42-BC82-5D1E8ED66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26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defRPr/>
            </a:pPr>
            <a:fld id="{11139F6A-FB59-5A48-A80B-C997DA68CCA6}" type="slidenum">
              <a:rPr lang="en-US" sz="1200">
                <a:solidFill>
                  <a:srgbClr val="000000"/>
                </a:solidFill>
              </a:rPr>
              <a:pPr defTabSz="914400" eaLnBrk="1" fontAlgn="base" hangingPunct="1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 sz="1200">
              <a:solidFill>
                <a:srgbClr val="000000"/>
              </a:solidFill>
            </a:endParaRPr>
          </a:p>
        </p:txBody>
      </p:sp>
      <p:sp>
        <p:nvSpPr>
          <p:cNvPr id="1536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ln/>
        </p:spPr>
      </p:sp>
      <p:sp>
        <p:nvSpPr>
          <p:cNvPr id="1536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Supplementary Fig 11a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: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 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Binge eating group </a:t>
            </a:r>
            <a:r>
              <a:rPr lang="en-US" b="1" baseline="0" dirty="0">
                <a:latin typeface="Arial" charset="0"/>
                <a:ea typeface="ＭＳ Ｐゴシック" charset="0"/>
                <a:cs typeface="ＭＳ Ｐゴシック" charset="0"/>
              </a:rPr>
              <a:t>differences by stress condition for food vs. non-food contrast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Both columns illustrate areas showing differential activation for the food vs non-food contrast between groups (BE vs. NB), with effects in the non-stress condition shown on the left column, and effects in the stress condition on the right column.</a:t>
            </a:r>
            <a:r>
              <a:rPr lang="en-US" dirty="0">
                <a:latin typeface="Arial" charset="0"/>
                <a:ea typeface="ＭＳ Ｐゴシック" charset="0"/>
                <a:cs typeface="ＭＳ Ｐゴシック" charset="0"/>
              </a:rPr>
              <a:t>;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 Sens-Mot indicates sensorimotor cortex; dlPFC, dorsolateral prefrontal cortex; PCu, precuneus; OFC, orbitofrontal cortex; Put, putamen; MTG, middle temporal gyrus; </a:t>
            </a:r>
            <a:r>
              <a:rPr lang="en-US" baseline="0" dirty="0" err="1">
                <a:latin typeface="Arial" charset="0"/>
                <a:ea typeface="ＭＳ Ｐゴシック" charset="0"/>
                <a:cs typeface="ＭＳ Ｐゴシック" charset="0"/>
              </a:rPr>
              <a:t>ilPFC</a:t>
            </a:r>
            <a:r>
              <a:rPr lang="en-US" baseline="0" dirty="0">
                <a:latin typeface="Arial" charset="0"/>
                <a:ea typeface="ＭＳ Ｐゴシック" charset="0"/>
                <a:cs typeface="ＭＳ Ｐゴシック" charset="0"/>
              </a:rPr>
              <a:t>, inferolateral prefrontal cortex; ACC, anterior cingulate cortex; PCC, posterior cingulate cortex; SFC, superior frontal cortex; MC, motor cortex</a:t>
            </a:r>
            <a:endParaRPr lang="en-US" dirty="0">
              <a:latin typeface="Arial" charset="0"/>
              <a:ea typeface="ＭＳ Ｐゴシック" charset="0"/>
              <a:cs typeface="ＭＳ Ｐゴシック" charset="0"/>
            </a:endParaRPr>
          </a:p>
          <a:p>
            <a:endParaRPr lang="en-US" b="1" dirty="0">
              <a:latin typeface="Arial" charset="0"/>
              <a:ea typeface="ＭＳ Ｐゴシック" charset="0"/>
              <a:cs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61012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0F2C8-7675-0642-A16C-4A1AF148D8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2CED4B-BEFE-F940-9C7A-CD73253C3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F34A5-25E2-B447-A53F-9D073353C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360D2-C67F-C344-8750-90720D270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3D513-73C0-064B-ACFB-0CD31BBB3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684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A7C21-050C-4045-B9F2-6D15D88BE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63D30-3ED2-534E-B147-B47FA7B8F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CF94A0-AB30-F940-8077-8D85C74E4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3FD6D-8140-EC4A-8EAE-20D09AAD7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6BA17F-104B-7245-B6AB-4E35888AE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2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A04A82-733E-A243-8105-DE4FD7FDC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36604C-882A-3A4A-9FE0-FE83ED19F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9A4B4-6917-F940-8ACF-2FCFD746D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4ACE-77C5-DC41-A118-B7B70BAC0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0A29F-433C-B04D-BB3E-3399305D4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0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E4B0-6E96-C84B-A3AC-F3135A28F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54D220-4A31-7C45-B2D5-C175828D33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EE3EE-4221-A64A-A74A-B771152A0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F6FF6-04A3-414C-BC56-DFEEC160F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E2E7C-1087-7645-BA81-F17C7C84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101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D2464-FD62-9C46-A480-8D6BD3B50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BBDD6-A130-5945-BDE9-7CA58DDDC5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F79F7-24F3-F84D-9E88-B2E39E614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47250-D516-8647-83D6-BBBC0E655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6AFE0C-07A4-F64C-BF98-8FD27540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2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14193-C656-DC46-B8A9-B222FF13E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A7DBE-8998-3A4D-B673-039F0088AD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60B051-E8C6-984C-80BC-143185EE4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8911C-93BF-4243-A980-F865C200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5D9BC-102C-124D-949A-472C7255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C95380-B911-D14F-AA33-5DAFB0276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2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B82FA-7F5D-C24A-9B4D-182913A14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52DF9F-EC62-934C-9395-186CF6E16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F69212-6AA7-6543-BB6F-E720EE1A71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701836-2BA1-2945-9ECF-DEB842F702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8A43C2-629C-0242-9FE9-645395A6FD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AC270-23AB-A248-8246-DB62E97C9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C7D824-A912-E34C-8A41-99E2B5A0E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5C3A9-C395-464B-A478-15D773A8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11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81D94-83EF-A04C-A85F-E0982392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CF3099-B0D0-354E-BC13-B6A23468F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995B67-1D64-334B-B516-F8F46E0E0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6DA786-63E2-A049-85CD-359BD4E8E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1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7D6F75-B4E9-B547-980B-FC2537D33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E4B715-FA60-4F44-BA94-D1B505102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5C863A-B507-AD4E-8F5F-F9601055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20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B7134-60A9-8A46-B94F-C10143890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B620D0-4FB1-6044-BB3E-88172B24D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7BB0E6-7FD1-AC48-A895-3B3AF16884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E33AA-CF53-074D-A527-ECD01CD40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50A1CD-59D1-174F-AB97-E54F9D8A3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3175B-9859-A040-907A-F226AD84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5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806D6-7E52-044F-903F-C79DA9487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380736-3B1D-4C4D-B3D3-5CD9299972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4294F-49AF-084D-AB23-77441BB377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78F24-50CF-0146-ADE0-4A867254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10A44-C307-3546-9256-B78B18CD6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A5BCF7-7C11-684F-AD2C-9FB61EE3E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3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48FCB-C307-AC46-8F6D-BD8682C14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23C883-8B6A-9244-8646-D179FDCD7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8730C-28DB-E845-BC46-5170EA59F9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3205F-A00F-E643-8439-09CBF47C612C}" type="datetimeFigureOut">
              <a:rPr lang="en-US" smtClean="0"/>
              <a:t>8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75CF5-27E2-9743-8AA5-3CCFC205BC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6EBC5B-EE2C-424C-A5A4-EAAD26F7E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AA702-382A-944E-B0C1-419F01E138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80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:a16="http://schemas.microsoft.com/office/drawing/2014/main" id="{164EA5AD-3A35-A040-9F24-AFFEF5FA11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34524" y="3826397"/>
            <a:ext cx="846285" cy="1094827"/>
          </a:xfrm>
          <a:prstGeom prst="rect">
            <a:avLst/>
          </a:prstGeom>
        </p:spPr>
      </p:pic>
      <p:sp>
        <p:nvSpPr>
          <p:cNvPr id="14343" name="Text Box 14"/>
          <p:cNvSpPr txBox="1">
            <a:spLocks noChangeArrowheads="1"/>
          </p:cNvSpPr>
          <p:nvPr/>
        </p:nvSpPr>
        <p:spPr bwMode="auto">
          <a:xfrm>
            <a:off x="3733800" y="454224"/>
            <a:ext cx="46482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Food &gt; Non-Food</a:t>
            </a:r>
          </a:p>
        </p:txBody>
      </p:sp>
      <p:sp>
        <p:nvSpPr>
          <p:cNvPr id="14373" name="Line 53"/>
          <p:cNvSpPr>
            <a:spLocks noChangeShapeType="1"/>
          </p:cNvSpPr>
          <p:nvPr/>
        </p:nvSpPr>
        <p:spPr bwMode="auto">
          <a:xfrm>
            <a:off x="5431133" y="1147120"/>
            <a:ext cx="0" cy="403860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pPr defTabSz="914428">
              <a:defRPr/>
            </a:pPr>
            <a:endParaRPr lang="en-US">
              <a:solidFill>
                <a:srgbClr val="000000"/>
              </a:solidFill>
              <a:cs typeface="+mn-cs"/>
            </a:endParaRPr>
          </a:p>
        </p:txBody>
      </p:sp>
      <p:sp>
        <p:nvSpPr>
          <p:cNvPr id="14374" name="Text Box 3"/>
          <p:cNvSpPr txBox="1">
            <a:spLocks noChangeArrowheads="1"/>
          </p:cNvSpPr>
          <p:nvPr/>
        </p:nvSpPr>
        <p:spPr bwMode="auto">
          <a:xfrm>
            <a:off x="2692762" y="1078781"/>
            <a:ext cx="3316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BE &gt; Non-BE</a:t>
            </a:r>
          </a:p>
        </p:txBody>
      </p:sp>
      <p:sp>
        <p:nvSpPr>
          <p:cNvPr id="65" name="Text Box 14"/>
          <p:cNvSpPr txBox="1">
            <a:spLocks noChangeArrowheads="1"/>
          </p:cNvSpPr>
          <p:nvPr/>
        </p:nvSpPr>
        <p:spPr bwMode="auto">
          <a:xfrm>
            <a:off x="3022770" y="827373"/>
            <a:ext cx="2590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FF"/>
                </a:solidFill>
              </a:rPr>
              <a:t>Non Stress Condition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40E6F790-3007-3C47-823B-9541CA433023}"/>
              </a:ext>
            </a:extLst>
          </p:cNvPr>
          <p:cNvGrpSpPr/>
          <p:nvPr/>
        </p:nvGrpSpPr>
        <p:grpSpPr>
          <a:xfrm>
            <a:off x="3792500" y="1630606"/>
            <a:ext cx="967593" cy="1052555"/>
            <a:chOff x="1448757" y="1602302"/>
            <a:chExt cx="967592" cy="1052555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B4A61455-F666-8247-AF1A-B54ED508ECA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48757" y="1602302"/>
              <a:ext cx="875872" cy="1052555"/>
            </a:xfrm>
            <a:prstGeom prst="rect">
              <a:avLst/>
            </a:prstGeom>
          </p:spPr>
        </p:pic>
        <p:sp>
          <p:nvSpPr>
            <p:cNvPr id="4" name="Oval 3">
              <a:extLst>
                <a:ext uri="{FF2B5EF4-FFF2-40B4-BE49-F238E27FC236}">
                  <a16:creationId xmlns:a16="http://schemas.microsoft.com/office/drawing/2014/main" id="{F096F8AB-0C8C-C242-B5CA-44470B82C1B7}"/>
                </a:ext>
              </a:extLst>
            </p:cNvPr>
            <p:cNvSpPr/>
            <p:nvPr/>
          </p:nvSpPr>
          <p:spPr>
            <a:xfrm>
              <a:off x="2232909" y="2537451"/>
              <a:ext cx="183440" cy="11472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91422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1" name="TextBox 20">
            <a:extLst>
              <a:ext uri="{FF2B5EF4-FFF2-40B4-BE49-F238E27FC236}">
                <a16:creationId xmlns:a16="http://schemas.microsoft.com/office/drawing/2014/main" id="{9CE91F59-9AB5-584E-BE35-3A6AAABD5B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3670" y="1855440"/>
            <a:ext cx="87588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Sens-</a:t>
            </a:r>
          </a:p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ot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4E24B9F4-2DDA-7D40-9C8E-FAE860AA8E0B}"/>
              </a:ext>
            </a:extLst>
          </p:cNvPr>
          <p:cNvCxnSpPr>
            <a:cxnSpLocks/>
          </p:cNvCxnSpPr>
          <p:nvPr/>
        </p:nvCxnSpPr>
        <p:spPr>
          <a:xfrm>
            <a:off x="3297215" y="2096801"/>
            <a:ext cx="542802" cy="62254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TextBox 40"/>
          <p:cNvSpPr txBox="1">
            <a:spLocks noChangeArrowheads="1"/>
          </p:cNvSpPr>
          <p:nvPr/>
        </p:nvSpPr>
        <p:spPr bwMode="auto">
          <a:xfrm>
            <a:off x="4696962" y="2434261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18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5868203-F799-1049-95FD-F1DB9AF8624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17845" y="2720392"/>
            <a:ext cx="843960" cy="1053209"/>
          </a:xfrm>
          <a:prstGeom prst="rect">
            <a:avLst/>
          </a:prstGeom>
        </p:spPr>
      </p:pic>
      <p:sp>
        <p:nvSpPr>
          <p:cNvPr id="55" name="TextBox 40">
            <a:extLst>
              <a:ext uri="{FF2B5EF4-FFF2-40B4-BE49-F238E27FC236}">
                <a16:creationId xmlns:a16="http://schemas.microsoft.com/office/drawing/2014/main" id="{1CAF5AF5-D6E8-7A47-8A1F-867C95916E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6189" y="3546024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24</a:t>
            </a:r>
          </a:p>
        </p:txBody>
      </p:sp>
      <p:sp>
        <p:nvSpPr>
          <p:cNvPr id="56" name="TextBox 29">
            <a:extLst>
              <a:ext uri="{FF2B5EF4-FFF2-40B4-BE49-F238E27FC236}">
                <a16:creationId xmlns:a16="http://schemas.microsoft.com/office/drawing/2014/main" id="{1732D4BA-28DD-4045-BF5D-4FADB745DE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1316" y="2564324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 err="1">
                <a:solidFill>
                  <a:srgbClr val="FFFFFF"/>
                </a:solidFill>
              </a:rPr>
              <a:t>dlPFC</a:t>
            </a:r>
            <a:endParaRPr lang="en-US" sz="1200" dirty="0">
              <a:solidFill>
                <a:srgbClr val="FFFFFF"/>
              </a:solidFill>
            </a:endParaRP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01F2BAED-C028-3144-B1D6-1C4BFBD54716}"/>
              </a:ext>
            </a:extLst>
          </p:cNvPr>
          <p:cNvCxnSpPr>
            <a:cxnSpLocks/>
          </p:cNvCxnSpPr>
          <p:nvPr/>
        </p:nvCxnSpPr>
        <p:spPr>
          <a:xfrm>
            <a:off x="3323342" y="2748523"/>
            <a:ext cx="612718" cy="16231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B17DA77-DD06-CC43-B4EF-8ECF6E7720A4}"/>
              </a:ext>
            </a:extLst>
          </p:cNvPr>
          <p:cNvGrpSpPr/>
          <p:nvPr/>
        </p:nvGrpSpPr>
        <p:grpSpPr>
          <a:xfrm>
            <a:off x="3811946" y="3829345"/>
            <a:ext cx="901298" cy="1091878"/>
            <a:chOff x="1469285" y="3845700"/>
            <a:chExt cx="901298" cy="1091878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DEE453E-C4CF-734F-8A4D-E5E759ED53B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69285" y="3845700"/>
              <a:ext cx="885016" cy="1042715"/>
            </a:xfrm>
            <a:prstGeom prst="rect">
              <a:avLst/>
            </a:prstGeom>
          </p:spPr>
        </p:pic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2F10451E-7457-7444-871D-EE88AA54EE94}"/>
                </a:ext>
              </a:extLst>
            </p:cNvPr>
            <p:cNvSpPr/>
            <p:nvPr/>
          </p:nvSpPr>
          <p:spPr>
            <a:xfrm>
              <a:off x="2324864" y="4789714"/>
              <a:ext cx="45719" cy="14786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91422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69" name="TextBox 40">
            <a:extLst>
              <a:ext uri="{FF2B5EF4-FFF2-40B4-BE49-F238E27FC236}">
                <a16:creationId xmlns:a16="http://schemas.microsoft.com/office/drawing/2014/main" id="{113440FF-2B7E-4848-A541-20A22F11C2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03071" y="4655108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28</a:t>
            </a:r>
          </a:p>
        </p:txBody>
      </p:sp>
      <p:sp>
        <p:nvSpPr>
          <p:cNvPr id="70" name="TextBox 29">
            <a:extLst>
              <a:ext uri="{FF2B5EF4-FFF2-40B4-BE49-F238E27FC236}">
                <a16:creationId xmlns:a16="http://schemas.microsoft.com/office/drawing/2014/main" id="{0B9170DE-68F7-9143-95D5-EFF28F149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4375" y="4450563"/>
            <a:ext cx="11729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PCu</a:t>
            </a: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57AA02F2-D6D7-3544-8C8D-567122B6E7BD}"/>
              </a:ext>
            </a:extLst>
          </p:cNvPr>
          <p:cNvCxnSpPr>
            <a:cxnSpLocks/>
          </p:cNvCxnSpPr>
          <p:nvPr/>
        </p:nvCxnSpPr>
        <p:spPr>
          <a:xfrm>
            <a:off x="3210633" y="4563292"/>
            <a:ext cx="931233" cy="73857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 Box 14">
            <a:extLst>
              <a:ext uri="{FF2B5EF4-FFF2-40B4-BE49-F238E27FC236}">
                <a16:creationId xmlns:a16="http://schemas.microsoft.com/office/drawing/2014/main" id="{443C75B0-17A1-ED4B-AA6B-985A7EA5A4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68636" y="806093"/>
            <a:ext cx="2590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FF"/>
                </a:solidFill>
              </a:rPr>
              <a:t>Stress Condition </a:t>
            </a:r>
          </a:p>
        </p:txBody>
      </p:sp>
      <p:sp>
        <p:nvSpPr>
          <p:cNvPr id="80" name="TextBox 20">
            <a:extLst>
              <a:ext uri="{FF2B5EF4-FFF2-40B4-BE49-F238E27FC236}">
                <a16:creationId xmlns:a16="http://schemas.microsoft.com/office/drawing/2014/main" id="{A65F17CD-ED22-A64E-89FB-33C0B58ADC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1658" y="2190725"/>
            <a:ext cx="875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TG</a:t>
            </a:r>
          </a:p>
        </p:txBody>
      </p:sp>
      <p:sp>
        <p:nvSpPr>
          <p:cNvPr id="82" name="TextBox 40">
            <a:extLst>
              <a:ext uri="{FF2B5EF4-FFF2-40B4-BE49-F238E27FC236}">
                <a16:creationId xmlns:a16="http://schemas.microsoft.com/office/drawing/2014/main" id="{3D88D21F-BE04-3E4A-AAC6-DF7F5F0501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71445" y="2420594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-4</a:t>
            </a:r>
          </a:p>
        </p:txBody>
      </p:sp>
      <p:pic>
        <p:nvPicPr>
          <p:cNvPr id="83" name="Picture 82">
            <a:extLst>
              <a:ext uri="{FF2B5EF4-FFF2-40B4-BE49-F238E27FC236}">
                <a16:creationId xmlns:a16="http://schemas.microsoft.com/office/drawing/2014/main" id="{BF29E1FA-0065-594F-AE80-60C800361EA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40174" y="2711436"/>
            <a:ext cx="840634" cy="1053209"/>
          </a:xfrm>
          <a:prstGeom prst="rect">
            <a:avLst/>
          </a:prstGeom>
        </p:spPr>
      </p:pic>
      <p:sp>
        <p:nvSpPr>
          <p:cNvPr id="84" name="TextBox 40">
            <a:extLst>
              <a:ext uri="{FF2B5EF4-FFF2-40B4-BE49-F238E27FC236}">
                <a16:creationId xmlns:a16="http://schemas.microsoft.com/office/drawing/2014/main" id="{37B184E8-AAAC-8D44-B8CE-D2A25A8236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75797" y="3530948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12</a:t>
            </a:r>
          </a:p>
        </p:txBody>
      </p:sp>
      <p:sp>
        <p:nvSpPr>
          <p:cNvPr id="85" name="TextBox 29">
            <a:extLst>
              <a:ext uri="{FF2B5EF4-FFF2-40B4-BE49-F238E27FC236}">
                <a16:creationId xmlns:a16="http://schemas.microsoft.com/office/drawing/2014/main" id="{29651F05-9918-8849-8F36-5DA1DABB17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9305" y="2795106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 err="1">
                <a:solidFill>
                  <a:srgbClr val="FFFFFF"/>
                </a:solidFill>
              </a:rPr>
              <a:t>ilPFC</a:t>
            </a:r>
            <a:endParaRPr lang="en-US" sz="1200" dirty="0">
              <a:solidFill>
                <a:srgbClr val="FFFFFF"/>
              </a:solidFill>
            </a:endParaRPr>
          </a:p>
        </p:txBody>
      </p: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35E0183B-130F-4C42-B3E7-B4CF95C78B68}"/>
              </a:ext>
            </a:extLst>
          </p:cNvPr>
          <p:cNvCxnSpPr>
            <a:cxnSpLocks/>
          </p:cNvCxnSpPr>
          <p:nvPr/>
        </p:nvCxnSpPr>
        <p:spPr>
          <a:xfrm>
            <a:off x="6107297" y="2946181"/>
            <a:ext cx="469034" cy="12554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TextBox 40">
            <a:extLst>
              <a:ext uri="{FF2B5EF4-FFF2-40B4-BE49-F238E27FC236}">
                <a16:creationId xmlns:a16="http://schemas.microsoft.com/office/drawing/2014/main" id="{29E9DACB-D853-8D4B-A4E9-6458EDA0AE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71439" y="4658718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20</a:t>
            </a:r>
          </a:p>
        </p:txBody>
      </p:sp>
      <p:sp>
        <p:nvSpPr>
          <p:cNvPr id="91" name="TextBox 29">
            <a:extLst>
              <a:ext uri="{FF2B5EF4-FFF2-40B4-BE49-F238E27FC236}">
                <a16:creationId xmlns:a16="http://schemas.microsoft.com/office/drawing/2014/main" id="{515A1636-DA6D-C142-9D1F-DE7F03ECA5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2363" y="4446209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PCC</a:t>
            </a:r>
          </a:p>
        </p:txBody>
      </p: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D2F3117E-1775-A940-AD67-99B31630862C}"/>
              </a:ext>
            </a:extLst>
          </p:cNvPr>
          <p:cNvCxnSpPr>
            <a:cxnSpLocks/>
          </p:cNvCxnSpPr>
          <p:nvPr/>
        </p:nvCxnSpPr>
        <p:spPr>
          <a:xfrm>
            <a:off x="6107298" y="4600220"/>
            <a:ext cx="705583" cy="1951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Text Box 3">
            <a:extLst>
              <a:ext uri="{FF2B5EF4-FFF2-40B4-BE49-F238E27FC236}">
                <a16:creationId xmlns:a16="http://schemas.microsoft.com/office/drawing/2014/main" id="{9ABDBA90-BF82-384F-B509-EDC68E0BCA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5802" y="1076792"/>
            <a:ext cx="3316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BE &gt; Non-BE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01EDE63A-FB18-1648-A11A-1E7EB7A54A2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434523" y="1635038"/>
            <a:ext cx="835006" cy="1088255"/>
          </a:xfrm>
          <a:prstGeom prst="rect">
            <a:avLst/>
          </a:prstGeom>
        </p:spPr>
      </p:pic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425DCA64-AD21-DA41-B6AB-E18BAD93889A}"/>
              </a:ext>
            </a:extLst>
          </p:cNvPr>
          <p:cNvCxnSpPr>
            <a:cxnSpLocks/>
          </p:cNvCxnSpPr>
          <p:nvPr/>
        </p:nvCxnSpPr>
        <p:spPr>
          <a:xfrm>
            <a:off x="6067243" y="2339106"/>
            <a:ext cx="403469" cy="89907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TextBox 20">
            <a:extLst>
              <a:ext uri="{FF2B5EF4-FFF2-40B4-BE49-F238E27FC236}">
                <a16:creationId xmlns:a16="http://schemas.microsoft.com/office/drawing/2014/main" id="{0E103E13-C278-304A-9F54-65C38B73D9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9304" y="1819803"/>
            <a:ext cx="9404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Put</a:t>
            </a:r>
          </a:p>
        </p:txBody>
      </p: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EC92FE56-7289-2E44-A5B5-206D3692B372}"/>
              </a:ext>
            </a:extLst>
          </p:cNvPr>
          <p:cNvCxnSpPr>
            <a:cxnSpLocks/>
          </p:cNvCxnSpPr>
          <p:nvPr/>
        </p:nvCxnSpPr>
        <p:spPr>
          <a:xfrm>
            <a:off x="6107298" y="2006580"/>
            <a:ext cx="561339" cy="109637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9" name="TextBox 29">
            <a:extLst>
              <a:ext uri="{FF2B5EF4-FFF2-40B4-BE49-F238E27FC236}">
                <a16:creationId xmlns:a16="http://schemas.microsoft.com/office/drawing/2014/main" id="{39634C7A-76E2-7343-BFB6-3347F8DA64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03001" y="1612982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OFC</a:t>
            </a:r>
          </a:p>
        </p:txBody>
      </p: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ECDC30AA-9AE0-6F47-9495-06E7215A6FF7}"/>
              </a:ext>
            </a:extLst>
          </p:cNvPr>
          <p:cNvCxnSpPr>
            <a:cxnSpLocks/>
            <a:stCxn id="99" idx="1"/>
          </p:cNvCxnSpPr>
          <p:nvPr/>
        </p:nvCxnSpPr>
        <p:spPr>
          <a:xfrm flipH="1">
            <a:off x="6920222" y="1751481"/>
            <a:ext cx="382778" cy="122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TextBox 29">
            <a:extLst>
              <a:ext uri="{FF2B5EF4-FFF2-40B4-BE49-F238E27FC236}">
                <a16:creationId xmlns:a16="http://schemas.microsoft.com/office/drawing/2014/main" id="{F218E22B-B38A-574E-8DC9-E0859F59C9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8003" y="3893207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ACC</a:t>
            </a:r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0DF252F7-34DC-DC43-B6B8-486012680D49}"/>
              </a:ext>
            </a:extLst>
          </p:cNvPr>
          <p:cNvCxnSpPr>
            <a:cxnSpLocks/>
          </p:cNvCxnSpPr>
          <p:nvPr/>
        </p:nvCxnSpPr>
        <p:spPr>
          <a:xfrm flipV="1">
            <a:off x="6107297" y="4014485"/>
            <a:ext cx="703014" cy="1722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8" name="Picture 37">
            <a:extLst>
              <a:ext uri="{FF2B5EF4-FFF2-40B4-BE49-F238E27FC236}">
                <a16:creationId xmlns:a16="http://schemas.microsoft.com/office/drawing/2014/main" id="{65358EF8-53F0-1F45-9944-66EDBD86461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593843" y="1627995"/>
            <a:ext cx="895407" cy="1095298"/>
          </a:xfrm>
          <a:prstGeom prst="rect">
            <a:avLst/>
          </a:prstGeom>
        </p:spPr>
      </p:pic>
      <p:sp>
        <p:nvSpPr>
          <p:cNvPr id="114" name="TextBox 40">
            <a:extLst>
              <a:ext uri="{FF2B5EF4-FFF2-40B4-BE49-F238E27FC236}">
                <a16:creationId xmlns:a16="http://schemas.microsoft.com/office/drawing/2014/main" id="{0584BB59-6467-6240-B145-6E4AB909FD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87782" y="2416237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30</a:t>
            </a:r>
          </a:p>
        </p:txBody>
      </p:sp>
      <p:sp>
        <p:nvSpPr>
          <p:cNvPr id="115" name="TextBox 29">
            <a:extLst>
              <a:ext uri="{FF2B5EF4-FFF2-40B4-BE49-F238E27FC236}">
                <a16:creationId xmlns:a16="http://schemas.microsoft.com/office/drawing/2014/main" id="{C87532E1-7993-D04D-9B63-85E52F8A20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28048" y="1608625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SFC</a:t>
            </a:r>
          </a:p>
        </p:txBody>
      </p: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204F792F-83A0-064D-A574-48004C58D6D5}"/>
              </a:ext>
            </a:extLst>
          </p:cNvPr>
          <p:cNvCxnSpPr>
            <a:cxnSpLocks/>
            <a:stCxn id="115" idx="1"/>
          </p:cNvCxnSpPr>
          <p:nvPr/>
        </p:nvCxnSpPr>
        <p:spPr>
          <a:xfrm flipH="1">
            <a:off x="9145269" y="1747124"/>
            <a:ext cx="382778" cy="122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7" name="TextBox 29">
            <a:extLst>
              <a:ext uri="{FF2B5EF4-FFF2-40B4-BE49-F238E27FC236}">
                <a16:creationId xmlns:a16="http://schemas.microsoft.com/office/drawing/2014/main" id="{FFD45B4A-A30D-414D-AF5F-F4D2148EAB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02222" y="1885624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 err="1">
                <a:solidFill>
                  <a:srgbClr val="FFFFFF"/>
                </a:solidFill>
              </a:rPr>
              <a:t>dlPFC</a:t>
            </a:r>
            <a:endParaRPr lang="en-US" sz="1200" dirty="0">
              <a:solidFill>
                <a:srgbClr val="FFFFFF"/>
              </a:solidFill>
            </a:endParaRPr>
          </a:p>
        </p:txBody>
      </p: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52E530BC-B9A9-AB46-9195-C0E805659A60}"/>
              </a:ext>
            </a:extLst>
          </p:cNvPr>
          <p:cNvCxnSpPr>
            <a:cxnSpLocks/>
          </p:cNvCxnSpPr>
          <p:nvPr/>
        </p:nvCxnSpPr>
        <p:spPr>
          <a:xfrm flipV="1">
            <a:off x="8349392" y="1964650"/>
            <a:ext cx="345335" cy="59473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3" name="Picture 42">
            <a:extLst>
              <a:ext uri="{FF2B5EF4-FFF2-40B4-BE49-F238E27FC236}">
                <a16:creationId xmlns:a16="http://schemas.microsoft.com/office/drawing/2014/main" id="{E121D93D-E720-C949-BD9E-2D263AD3689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606268" y="2702822"/>
            <a:ext cx="865716" cy="1063226"/>
          </a:xfrm>
          <a:prstGeom prst="rect">
            <a:avLst/>
          </a:prstGeom>
        </p:spPr>
      </p:pic>
      <p:sp>
        <p:nvSpPr>
          <p:cNvPr id="124" name="TextBox 40">
            <a:extLst>
              <a:ext uri="{FF2B5EF4-FFF2-40B4-BE49-F238E27FC236}">
                <a16:creationId xmlns:a16="http://schemas.microsoft.com/office/drawing/2014/main" id="{46426384-F376-9E48-9791-D46EF41F8B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87782" y="3540839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000" dirty="0">
                <a:solidFill>
                  <a:srgbClr val="FFFFFF"/>
                </a:solidFill>
              </a:rPr>
              <a:t>z=+52</a:t>
            </a:r>
          </a:p>
        </p:txBody>
      </p:sp>
      <p:sp>
        <p:nvSpPr>
          <p:cNvPr id="126" name="TextBox 29">
            <a:extLst>
              <a:ext uri="{FF2B5EF4-FFF2-40B4-BE49-F238E27FC236}">
                <a16:creationId xmlns:a16="http://schemas.microsoft.com/office/drawing/2014/main" id="{736DE29A-430D-1842-8894-DC58AA3193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97864" y="3030805"/>
            <a:ext cx="911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defTabSz="914428" eaLnBrk="1" hangingPunct="1">
              <a:defRPr/>
            </a:pPr>
            <a:r>
              <a:rPr lang="en-US" sz="1200" dirty="0">
                <a:solidFill>
                  <a:srgbClr val="FFFFFF"/>
                </a:solidFill>
              </a:rPr>
              <a:t>MC</a:t>
            </a:r>
          </a:p>
        </p:txBody>
      </p: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62504237-8D6B-834E-ABEB-5754678F19BA}"/>
              </a:ext>
            </a:extLst>
          </p:cNvPr>
          <p:cNvCxnSpPr>
            <a:cxnSpLocks/>
            <a:endCxn id="126" idx="3"/>
          </p:cNvCxnSpPr>
          <p:nvPr/>
        </p:nvCxnSpPr>
        <p:spPr>
          <a:xfrm>
            <a:off x="8132766" y="3165240"/>
            <a:ext cx="576450" cy="4065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8153401" y="4706780"/>
            <a:ext cx="1853287" cy="246221"/>
          </a:xfrm>
          <a:prstGeom prst="rect">
            <a:avLst/>
          </a:prstGeom>
          <a:noFill/>
          <a:ln>
            <a:noFill/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US" altLang="zh-CN" sz="1000" dirty="0">
                <a:solidFill>
                  <a:srgbClr val="FFFFFF"/>
                </a:solidFill>
              </a:rPr>
              <a:t>Posterior probability &gt;98.75% </a:t>
            </a:r>
            <a:endParaRPr lang="en-US" altLang="zh-CN" sz="1000" dirty="0">
              <a:solidFill>
                <a:srgbClr val="000000"/>
              </a:solidFill>
            </a:endParaRP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85C2E2B0-4FF0-452C-B308-E5F5434F4D5A}"/>
              </a:ext>
            </a:extLst>
          </p:cNvPr>
          <p:cNvGrpSpPr/>
          <p:nvPr/>
        </p:nvGrpSpPr>
        <p:grpSpPr>
          <a:xfrm>
            <a:off x="7850692" y="4222824"/>
            <a:ext cx="2488104" cy="320204"/>
            <a:chOff x="4267202" y="5438365"/>
            <a:chExt cx="2488104" cy="320204"/>
          </a:xfrm>
        </p:grpSpPr>
        <p:grpSp>
          <p:nvGrpSpPr>
            <p:cNvPr id="62" name="Group 138">
              <a:extLst>
                <a:ext uri="{FF2B5EF4-FFF2-40B4-BE49-F238E27FC236}">
                  <a16:creationId xmlns:a16="http://schemas.microsoft.com/office/drawing/2014/main" id="{14DD6522-A972-49C4-AF14-6729F0F4EA3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267202" y="5440365"/>
              <a:ext cx="2249620" cy="318204"/>
              <a:chOff x="3599542" y="6265456"/>
              <a:chExt cx="2249636" cy="317891"/>
            </a:xfrm>
          </p:grpSpPr>
          <p:pic>
            <p:nvPicPr>
              <p:cNvPr id="87" name="Picture 30" descr="blueColorbar">
                <a:extLst>
                  <a:ext uri="{FF2B5EF4-FFF2-40B4-BE49-F238E27FC236}">
                    <a16:creationId xmlns:a16="http://schemas.microsoft.com/office/drawing/2014/main" id="{F0C9C3F6-5B40-4F5E-9C45-235B8F4A5D38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4845364" y="6483261"/>
                <a:ext cx="1003814" cy="93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8" name="Picture 31" descr="redColorbar">
                <a:extLst>
                  <a:ext uri="{FF2B5EF4-FFF2-40B4-BE49-F238E27FC236}">
                    <a16:creationId xmlns:a16="http://schemas.microsoft.com/office/drawing/2014/main" id="{A2C71B25-1F18-4A92-84EF-46A85C6888FC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596"/>
              <a:stretch>
                <a:fillRect/>
              </a:stretch>
            </p:blipFill>
            <p:spPr bwMode="auto">
              <a:xfrm rot="10800000">
                <a:off x="3711459" y="6489632"/>
                <a:ext cx="1139610" cy="937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9" name="Text Box 32">
                <a:extLst>
                  <a:ext uri="{FF2B5EF4-FFF2-40B4-BE49-F238E27FC236}">
                    <a16:creationId xmlns:a16="http://schemas.microsoft.com/office/drawing/2014/main" id="{C4966054-1CF0-4429-81E1-60D4E475973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99542" y="6265456"/>
                <a:ext cx="752041" cy="2459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1000" dirty="0">
                    <a:solidFill>
                      <a:schemeClr val="bg1"/>
                    </a:solidFill>
                    <a:cs typeface="Arial" charset="0"/>
                  </a:rPr>
                  <a:t> </a:t>
                </a:r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9.99%</a:t>
                </a:r>
                <a:endParaRPr lang="en-US" altLang="zh-CN" sz="1000" dirty="0">
                  <a:solidFill>
                    <a:schemeClr val="bg1"/>
                  </a:solidFill>
                  <a:cs typeface="Arial" charset="0"/>
                </a:endParaRPr>
              </a:p>
            </p:txBody>
          </p:sp>
          <p:sp>
            <p:nvSpPr>
              <p:cNvPr id="95" name="Text Box 32">
                <a:extLst>
                  <a:ext uri="{FF2B5EF4-FFF2-40B4-BE49-F238E27FC236}">
                    <a16:creationId xmlns:a16="http://schemas.microsoft.com/office/drawing/2014/main" id="{C54D3A22-E332-4573-94DD-6C661FBD9B6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05323" y="6265456"/>
                <a:ext cx="630105" cy="2306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altLang="zh-CN" sz="900" dirty="0">
                    <a:solidFill>
                      <a:schemeClr val="bg1"/>
                    </a:solidFill>
                    <a:cs typeface="Arial" charset="0"/>
                  </a:rPr>
                  <a:t>98.75% </a:t>
                </a:r>
              </a:p>
            </p:txBody>
          </p:sp>
        </p:grpSp>
        <p:sp>
          <p:nvSpPr>
            <p:cNvPr id="63" name="Text Box 32">
              <a:extLst>
                <a:ext uri="{FF2B5EF4-FFF2-40B4-BE49-F238E27FC236}">
                  <a16:creationId xmlns:a16="http://schemas.microsoft.com/office/drawing/2014/main" id="{58412813-DA76-4597-B6E8-C9193CCA6F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88299" y="5440364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 -98.75%</a:t>
              </a:r>
            </a:p>
          </p:txBody>
        </p:sp>
        <p:sp>
          <p:nvSpPr>
            <p:cNvPr id="79" name="Text Box 32">
              <a:extLst>
                <a:ext uri="{FF2B5EF4-FFF2-40B4-BE49-F238E27FC236}">
                  <a16:creationId xmlns:a16="http://schemas.microsoft.com/office/drawing/2014/main" id="{EB7D3DAA-50A3-48C6-AF86-BB7C98858B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190" y="5438365"/>
              <a:ext cx="73411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zh-CN" sz="900" dirty="0">
                  <a:solidFill>
                    <a:schemeClr val="bg1"/>
                  </a:solidFill>
                  <a:cs typeface="Arial" charset="0"/>
                </a:rPr>
                <a:t>-99.99%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82705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88</Words>
  <Application>Microsoft Macintosh PowerPoint</Application>
  <PresentationFormat>Widescreen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hys Aghababian</dc:creator>
  <cp:lastModifiedBy>Microsoft Office User</cp:lastModifiedBy>
  <cp:revision>8</cp:revision>
  <dcterms:created xsi:type="dcterms:W3CDTF">2021-05-24T12:55:43Z</dcterms:created>
  <dcterms:modified xsi:type="dcterms:W3CDTF">2022-08-31T20:48:22Z</dcterms:modified>
</cp:coreProperties>
</file>